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821134-7BEA-44E0-9A4B-42DD43E039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5DA7C4-CB74-405E-891E-1988C6F3DD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0626B-ED70-48A2-8887-1B08ED0CA0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119AB-9CEB-482F-9957-022CB7D859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7EA841-3E9C-43F1-8186-7BBF8CDAFE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CD942C-84B2-4B59-85AC-C1186544E6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9E350C-6BBD-4D89-843E-05437CE261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6F9106-1403-4D9A-871E-D1BAF609B7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AF2D10-CEBC-425D-872A-07969265F5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65EAC3-5390-4E78-8CB6-70CB040146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DE256C-669F-4DA0-A2B4-609439FF73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2E6276-4459-44FC-A600-D96AA5BFB8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4A2670-FE27-43F1-81B9-301F8E8B2E6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69160" y="955800"/>
            <a:ext cx="5293080" cy="2455920"/>
            <a:chOff x="569160" y="955800"/>
            <a:chExt cx="5293080" cy="245592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4182" t="3843" r="11613" b="14401"/>
            <a:stretch/>
          </p:blipFill>
          <p:spPr>
            <a:xfrm>
              <a:off x="1620720" y="1201680"/>
              <a:ext cx="4241520" cy="1993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758520" y="1225440"/>
              <a:ext cx="1023840" cy="195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70000"/>
                </a:lnSpc>
                <a:tabLst>
                  <a:tab algn="l" pos="0"/>
                  <a:tab algn="ctr" pos="231840"/>
                  <a:tab algn="ctr" pos="62532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ng/ml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231840"/>
                  <a:tab algn="ctr" pos="62532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7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231840"/>
                  <a:tab algn="ctr" pos="62532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6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231840"/>
                  <a:tab algn="ctr" pos="62532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.5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6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70000"/>
                </a:lnSpc>
                <a:tabLst>
                  <a:tab algn="l" pos="0"/>
                  <a:tab algn="ctr" pos="231840"/>
                  <a:tab algn="ctr" pos="62532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7.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6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70000"/>
                </a:lnSpc>
                <a:tabLst>
                  <a:tab algn="l" pos="0"/>
                  <a:tab algn="ctr" pos="231840"/>
                  <a:tab algn="ctr" pos="62532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vera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569160" y="1682640"/>
              <a:ext cx="266040" cy="1023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7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7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7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785520" y="1771560"/>
              <a:ext cx="180720" cy="323640"/>
            </a:xfrm>
            <a:custGeom>
              <a:avLst/>
              <a:gdLst>
                <a:gd name="textAreaLeft" fmla="*/ 115560 w 180720"/>
                <a:gd name="textAreaRight" fmla="*/ 181080 w 180720"/>
                <a:gd name="textAreaTop" fmla="*/ 8280 h 323640"/>
                <a:gd name="textAreaBottom" fmla="*/ 315360 h 323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785520" y="2381040"/>
              <a:ext cx="180720" cy="323640"/>
            </a:xfrm>
            <a:custGeom>
              <a:avLst/>
              <a:gdLst>
                <a:gd name="textAreaLeft" fmla="*/ 115560 w 180720"/>
                <a:gd name="textAreaRight" fmla="*/ 181080 w 180720"/>
                <a:gd name="textAreaTop" fmla="*/ 8280 h 323640"/>
                <a:gd name="textAreaBottom" fmla="*/ 315360 h 32364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5400" y="10800"/>
                    <a:pt x="0" y="10800"/>
                  </a:cubicBezTo>
                  <a:cubicBezTo>
                    <a:pt x="54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162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663120" y="95580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8" name=""/>
            <p:cNvGrpSpPr/>
            <p:nvPr/>
          </p:nvGrpSpPr>
          <p:grpSpPr>
            <a:xfrm>
              <a:off x="5050800" y="1558800"/>
              <a:ext cx="619920" cy="1297080"/>
              <a:chOff x="5050800" y="1558800"/>
              <a:chExt cx="619920" cy="1297080"/>
            </a:xfrm>
          </p:grpSpPr>
          <p:sp>
            <p:nvSpPr>
              <p:cNvPr id="49" name=""/>
              <p:cNvSpPr/>
              <p:nvPr/>
            </p:nvSpPr>
            <p:spPr>
              <a:xfrm>
                <a:off x="5073840" y="1558800"/>
                <a:ext cx="596880" cy="12970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RPG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PRT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NIP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TIF3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TIF3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1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200" spc="-1" strike="noStrike">
                    <a:solidFill>
                      <a:srgbClr val="000000"/>
                    </a:solidFill>
                    <a:latin typeface="Arial"/>
                  </a:rPr>
                  <a:t>TIF1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5050800" y="1642320"/>
                <a:ext cx="141120" cy="12204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760" bIns="-5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5050800" y="1842480"/>
                <a:ext cx="141120" cy="122040"/>
              </a:xfrm>
              <a:prstGeom prst="triangle">
                <a:avLst>
                  <a:gd name="adj" fmla="val 50000"/>
                </a:avLst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-5760" bIns="-576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5050800" y="2034720"/>
                <a:ext cx="136440" cy="136080"/>
              </a:xfrm>
              <a:prstGeom prst="diamond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1600" bIns="21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5050800" y="2244240"/>
                <a:ext cx="136440" cy="136080"/>
              </a:xfrm>
              <a:prstGeom prst="diamond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1600" bIns="216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5066640" y="2469600"/>
                <a:ext cx="122040" cy="12168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8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5076360" y="2650680"/>
                <a:ext cx="121680" cy="1216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6" name=""/>
            <p:cNvSpPr/>
            <p:nvPr/>
          </p:nvSpPr>
          <p:spPr>
            <a:xfrm>
              <a:off x="696600" y="3135240"/>
              <a:ext cx="2428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(1 = verrucarin A; 2 = roridin A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7" name=""/>
          <p:cNvGrpSpPr/>
          <p:nvPr/>
        </p:nvGrpSpPr>
        <p:grpSpPr>
          <a:xfrm>
            <a:off x="6087240" y="934920"/>
            <a:ext cx="2653560" cy="2378160"/>
            <a:chOff x="6087240" y="934920"/>
            <a:chExt cx="2653560" cy="2378160"/>
          </a:xfrm>
        </p:grpSpPr>
        <p:pic>
          <p:nvPicPr>
            <p:cNvPr id="58" name="" descr=""/>
            <p:cNvPicPr/>
            <p:nvPr/>
          </p:nvPicPr>
          <p:blipFill>
            <a:blip r:embed="rId2"/>
            <a:stretch/>
          </p:blipFill>
          <p:spPr>
            <a:xfrm>
              <a:off x="6642360" y="1420920"/>
              <a:ext cx="2093760" cy="1866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"/>
            <p:cNvSpPr/>
            <p:nvPr/>
          </p:nvSpPr>
          <p:spPr>
            <a:xfrm>
              <a:off x="6087240" y="1414440"/>
              <a:ext cx="596880" cy="1898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HIS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SUI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SUI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RPG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PRT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NIP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TIF3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TIF3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11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200" spc="-1" strike="noStrike">
                  <a:solidFill>
                    <a:srgbClr val="000000"/>
                  </a:solidFill>
                  <a:latin typeface="Arial"/>
                </a:rPr>
                <a:t>TIF1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6569280" y="1211400"/>
              <a:ext cx="2171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ctr" pos="343080"/>
                  <a:tab algn="ctr" pos="1028880"/>
                  <a:tab algn="ctr" pos="1714680"/>
                  <a:tab algn="l" pos="2057400"/>
                  <a:tab algn="l" pos="3086280"/>
                  <a:tab algn="l" pos="4114800"/>
                  <a:tab algn="l" pos="5143680"/>
                  <a:tab algn="l" pos="6172200"/>
                  <a:tab algn="l" pos="7201080"/>
                  <a:tab algn="l" pos="8229600"/>
                  <a:tab algn="l" pos="9258480"/>
                  <a:tab algn="l" pos="102870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7344000" y="934920"/>
              <a:ext cx="13665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oridin A (ng/ml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7375680" y="1225440"/>
              <a:ext cx="1276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6275520" y="100980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宋体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4" name=""/>
          <p:cNvSpPr/>
          <p:nvPr/>
        </p:nvSpPr>
        <p:spPr>
          <a:xfrm>
            <a:off x="744480" y="3662280"/>
            <a:ext cx="78296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8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CaFT profiles of mycotoxins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A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aFT profiles of roridin A and verrucarin A with highlighted strains for subunits of eIF3 [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RPG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91.6345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PRT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658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NIP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4635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,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TIF34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296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TIF35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7236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] and eIF1A [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TIF1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535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]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Spot tests of heterozygous deletion strains corresponding to the five subunits of eIF3 and eIF1A, together with strains for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HIS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and the two subunits of eIF2: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SUI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621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 and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SUI3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(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orf19.716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). Note that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TIF35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is severely haploinsufficient under normal growth condition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4-11T14:46:39Z</dcterms:created>
  <dc:creator>xudemin</dc:creator>
  <dc:description/>
  <dc:language>en-US</dc:language>
  <cp:lastModifiedBy>xudemin</cp:lastModifiedBy>
  <dcterms:modified xsi:type="dcterms:W3CDTF">2007-05-17T15:24:35Z</dcterms:modified>
  <cp:revision>3</cp:revision>
  <dc:subject/>
  <dc:title>Slide 1</dc:title>
</cp:coreProperties>
</file>